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0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72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OHI-FSI\VOLI\Home\LARG\MCPHERSON\Sebastien\Results%202018\JAN%2031%202018%20SE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2520792327382405E-2"/>
          <c:y val="1.5465900046551267E-2"/>
          <c:w val="0.89303475350716388"/>
          <c:h val="0.77497787862705225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W$34:$W$43</c:f>
                <c:numCache>
                  <c:formatCode>General</c:formatCode>
                  <c:ptCount val="10"/>
                  <c:pt idx="0">
                    <c:v>0.29773659162728838</c:v>
                  </c:pt>
                  <c:pt idx="1">
                    <c:v>0.21285774724664969</c:v>
                  </c:pt>
                  <c:pt idx="2">
                    <c:v>0.32136019684687817</c:v>
                  </c:pt>
                  <c:pt idx="3">
                    <c:v>0.14476519232102525</c:v>
                  </c:pt>
                  <c:pt idx="4">
                    <c:v>0.24863504098627734</c:v>
                  </c:pt>
                  <c:pt idx="5">
                    <c:v>0.18301767060986654</c:v>
                  </c:pt>
                  <c:pt idx="6">
                    <c:v>0.22234288047325959</c:v>
                  </c:pt>
                  <c:pt idx="7">
                    <c:v>0.23535499590615042</c:v>
                  </c:pt>
                  <c:pt idx="8">
                    <c:v>0.21421708369612735</c:v>
                  </c:pt>
                  <c:pt idx="9">
                    <c:v>0.44195717523546896</c:v>
                  </c:pt>
                </c:numCache>
              </c:numRef>
            </c:plus>
            <c:minus>
              <c:numRef>
                <c:f>Sheet1!$W$34:$W$43</c:f>
                <c:numCache>
                  <c:formatCode>General</c:formatCode>
                  <c:ptCount val="10"/>
                  <c:pt idx="0">
                    <c:v>0.29773659162728838</c:v>
                  </c:pt>
                  <c:pt idx="1">
                    <c:v>0.21285774724664969</c:v>
                  </c:pt>
                  <c:pt idx="2">
                    <c:v>0.32136019684687817</c:v>
                  </c:pt>
                  <c:pt idx="3">
                    <c:v>0.14476519232102525</c:v>
                  </c:pt>
                  <c:pt idx="4">
                    <c:v>0.24863504098627734</c:v>
                  </c:pt>
                  <c:pt idx="5">
                    <c:v>0.18301767060986654</c:v>
                  </c:pt>
                  <c:pt idx="6">
                    <c:v>0.22234288047325959</c:v>
                  </c:pt>
                  <c:pt idx="7">
                    <c:v>0.23535499590615042</c:v>
                  </c:pt>
                  <c:pt idx="8">
                    <c:v>0.21421708369612735</c:v>
                  </c:pt>
                  <c:pt idx="9">
                    <c:v>0.44195717523546896</c:v>
                  </c:pt>
                </c:numCache>
              </c:numRef>
            </c:minus>
          </c:errBars>
          <c:cat>
            <c:multiLvlStrRef>
              <c:f>Sheet1!$T$34:$U$43</c:f>
              <c:multiLvlStrCache>
                <c:ptCount val="10"/>
                <c:lvl>
                  <c:pt idx="0">
                    <c:v>ABHD2</c:v>
                  </c:pt>
                  <c:pt idx="1">
                    <c:v>HAPLN3</c:v>
                  </c:pt>
                  <c:pt idx="2">
                    <c:v>MFGE8</c:v>
                  </c:pt>
                  <c:pt idx="3">
                    <c:v>SRP14</c:v>
                  </c:pt>
                  <c:pt idx="4">
                    <c:v>GAPDH</c:v>
                  </c:pt>
                  <c:pt idx="5">
                    <c:v>ABHD2</c:v>
                  </c:pt>
                  <c:pt idx="6">
                    <c:v>HAPLN3</c:v>
                  </c:pt>
                  <c:pt idx="7">
                    <c:v>MFGE8</c:v>
                  </c:pt>
                  <c:pt idx="8">
                    <c:v>SRP14</c:v>
                  </c:pt>
                  <c:pt idx="9">
                    <c:v>GAPDH</c:v>
                  </c:pt>
                </c:lvl>
                <c:lvl>
                  <c:pt idx="0">
                    <c:v>VP160</c:v>
                  </c:pt>
                  <c:pt idx="5">
                    <c:v>KRAB</c:v>
                  </c:pt>
                </c:lvl>
              </c:multiLvlStrCache>
            </c:multiLvlStrRef>
          </c:cat>
          <c:val>
            <c:numRef>
              <c:f>Sheet1!$V$34:$V$43</c:f>
              <c:numCache>
                <c:formatCode>0.00E+00</c:formatCode>
                <c:ptCount val="10"/>
                <c:pt idx="0">
                  <c:v>1.012580278103832</c:v>
                </c:pt>
                <c:pt idx="1">
                  <c:v>0.98816134538382749</c:v>
                </c:pt>
                <c:pt idx="2">
                  <c:v>1.1358447302609078</c:v>
                </c:pt>
                <c:pt idx="3">
                  <c:v>0.91722594437604521</c:v>
                </c:pt>
                <c:pt idx="4">
                  <c:v>1.2776197950017696</c:v>
                </c:pt>
                <c:pt idx="5">
                  <c:v>1.0130344185554214</c:v>
                </c:pt>
                <c:pt idx="6">
                  <c:v>1.0903281147955921</c:v>
                </c:pt>
                <c:pt idx="7">
                  <c:v>1.2458336710741276</c:v>
                </c:pt>
                <c:pt idx="8">
                  <c:v>1.0278713056522097</c:v>
                </c:pt>
                <c:pt idx="9">
                  <c:v>0.889679264039104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80-4D38-81A7-3357B31742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6078976"/>
        <c:axId val="66088960"/>
      </c:barChart>
      <c:catAx>
        <c:axId val="66078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6088960"/>
        <c:crosses val="autoZero"/>
        <c:auto val="1"/>
        <c:lblAlgn val="ctr"/>
        <c:lblOffset val="100"/>
        <c:noMultiLvlLbl val="0"/>
      </c:catAx>
      <c:valAx>
        <c:axId val="6608896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crossAx val="66078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5" name="TextBox 6"/>
          <p:cNvSpPr txBox="1">
            <a:spLocks noChangeArrowheads="1"/>
          </p:cNvSpPr>
          <p:nvPr/>
        </p:nvSpPr>
        <p:spPr bwMode="auto">
          <a:xfrm>
            <a:off x="576262" y="6119336"/>
            <a:ext cx="8224838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2 Fig.  No evidence of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 cis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regulation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y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RP11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in HEK293T cell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Expression levels of genes proximal to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RP1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were assessed after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RP1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levels were modulated with either VP160 or KRAB in the presence of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</a:t>
            </a:r>
            <a:r>
              <a:rPr lang="en-CA" sz="1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86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Results are from 4 independent biological replicate (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Averag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±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.D.)</a:t>
            </a:r>
          </a:p>
        </p:txBody>
      </p:sp>
      <p:graphicFrame>
        <p:nvGraphicFramePr>
          <p:cNvPr id="10" name="Chart 9"/>
          <p:cNvGraphicFramePr/>
          <p:nvPr>
            <p:extLst/>
          </p:nvPr>
        </p:nvGraphicFramePr>
        <p:xfrm>
          <a:off x="3088823" y="863600"/>
          <a:ext cx="3654878" cy="48101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2" name="Straight Connector 11"/>
          <p:cNvCxnSpPr/>
          <p:nvPr/>
        </p:nvCxnSpPr>
        <p:spPr>
          <a:xfrm>
            <a:off x="3340100" y="2552700"/>
            <a:ext cx="3403600" cy="0"/>
          </a:xfrm>
          <a:prstGeom prst="line">
            <a:avLst/>
          </a:prstGeom>
          <a:ln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481712" y="2794449"/>
            <a:ext cx="41778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Relative expression level</a:t>
            </a:r>
          </a:p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(normalized to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crRN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plasmid)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5579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4</TotalTime>
  <Words>6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0</cp:revision>
  <dcterms:created xsi:type="dcterms:W3CDTF">2017-11-23T16:07:42Z</dcterms:created>
  <dcterms:modified xsi:type="dcterms:W3CDTF">2019-10-09T12:48:01Z</dcterms:modified>
</cp:coreProperties>
</file>